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wmf" ContentType="image/x-wmf"/>
  <Override PartName="/ppt/media/image10.wmf" ContentType="image/x-wmf"/>
  <Override PartName="/ppt/media/image6.wmf" ContentType="image/x-wmf"/>
  <Override PartName="/ppt/media/image7.png" ContentType="image/png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8999538" cy="10799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1142640"/>
            <a:ext cx="2571840" cy="3086280"/>
          </a:xfrm>
          <a:prstGeom prst="rect">
            <a:avLst/>
          </a:prstGeom>
          <a:noFill/>
          <a:ln w="12600">
            <a:solidFill>
              <a:srgbClr val="000000"/>
            </a:solidFill>
            <a:round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EFCACD-B88E-4856-8283-A85C1CF604A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sldImg"/>
          </p:nvPr>
        </p:nvSpPr>
        <p:spPr>
          <a:xfrm>
            <a:off x="2143080" y="1143000"/>
            <a:ext cx="2571840" cy="3086280"/>
          </a:xfrm>
          <a:prstGeom prst="rect">
            <a:avLst/>
          </a:prstGeom>
          <a:ln w="0">
            <a:noFill/>
          </a:ln>
        </p:spPr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FAA73F-1BC2-465E-BFDA-97B31A645861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E5221D-2940-4062-98E5-C1C8063D2F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48920" y="2519280"/>
            <a:ext cx="810108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48920" y="6242400"/>
            <a:ext cx="810108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17188-CD9D-466D-92D0-712405DBA2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48920" y="251928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00080" y="251928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48920" y="624240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00080" y="624240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04501D-1461-4BA2-9C9B-4D09203080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48920" y="2519280"/>
            <a:ext cx="2608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187800" y="2519280"/>
            <a:ext cx="2608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27040" y="2519280"/>
            <a:ext cx="2608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48920" y="6242400"/>
            <a:ext cx="2608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187800" y="6242400"/>
            <a:ext cx="2608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27040" y="6242400"/>
            <a:ext cx="2608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12A7E1-73A0-4B27-8DC8-5F990B6C40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48920" y="2519280"/>
            <a:ext cx="8101080" cy="7128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9"/>
              </a:spcBef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A44148-7D19-46B6-B476-7EBBA52F82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48920" y="2519280"/>
            <a:ext cx="8101080" cy="712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B1019-9A5E-49AE-902D-CC437E952D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48920" y="2519280"/>
            <a:ext cx="3953160" cy="712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00080" y="2519280"/>
            <a:ext cx="3953160" cy="712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1C94C-1DC4-41F2-9D41-5F53FE1FE6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B2B24-4DF2-4A00-89A3-883990DDDC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48920" y="431280"/>
            <a:ext cx="8101080" cy="834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9"/>
              </a:spcBef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12917C-0A20-44CC-8C1B-EDC7AC0909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48920" y="251928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00080" y="2519280"/>
            <a:ext cx="3953160" cy="712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48920" y="624240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59AB7-D010-405C-814B-976D9540F3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48920" y="2519280"/>
            <a:ext cx="3953160" cy="712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00080" y="251928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00080" y="624240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AFE81F-7B6D-49AF-98A4-0149F18F26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48920" y="251928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00080" y="2519280"/>
            <a:ext cx="39531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48920" y="6242400"/>
            <a:ext cx="810108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9"/>
              </a:spcBef>
              <a:buNone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7D3A2-3208-4FE4-BB68-C3BB410E1B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48920" y="431280"/>
            <a:ext cx="810108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48920" y="2519280"/>
            <a:ext cx="8101080" cy="7128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36600" indent="-336600">
              <a:spcBef>
                <a:spcPts val="99"/>
              </a:spcBef>
              <a:buClr>
                <a:srgbClr val="000000"/>
              </a:buClr>
              <a:buFont typeface="Arial"/>
              <a:buChar char="•"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1" marL="731880" indent="-281160">
              <a:spcBef>
                <a:spcPts val="99"/>
              </a:spcBef>
              <a:buClr>
                <a:srgbClr val="000000"/>
              </a:buClr>
              <a:buFont typeface="Arial"/>
              <a:buChar char="–"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2" marL="1125360" indent="-225360">
              <a:spcBef>
                <a:spcPts val="99"/>
              </a:spcBef>
              <a:buClr>
                <a:srgbClr val="000000"/>
              </a:buClr>
              <a:buFont typeface="Arial"/>
              <a:buChar char="•"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3" marL="1574640" indent="-225360">
              <a:spcBef>
                <a:spcPts val="99"/>
              </a:spcBef>
              <a:buClr>
                <a:srgbClr val="000000"/>
              </a:buClr>
              <a:buFont typeface="Arial"/>
              <a:buChar char="–"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4" marL="2025720" indent="-225360">
              <a:spcBef>
                <a:spcPts val="99"/>
              </a:spcBef>
              <a:buClr>
                <a:srgbClr val="000000"/>
              </a:buClr>
              <a:buFont typeface="Arial"/>
              <a:buChar char="»"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5" marL="2025720" indent="-225360">
              <a:spcBef>
                <a:spcPts val="99"/>
              </a:spcBef>
              <a:buClr>
                <a:srgbClr val="000000"/>
              </a:buClr>
              <a:buFont typeface="Arial"/>
              <a:buChar char="»"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  <a:p>
            <a:pPr lvl="6" marL="2025720" indent="-225360">
              <a:spcBef>
                <a:spcPts val="99"/>
              </a:spcBef>
              <a:buClr>
                <a:srgbClr val="000000"/>
              </a:buClr>
              <a:buFont typeface="Arial"/>
              <a:buChar char="»"/>
              <a:tabLst>
                <a:tab algn="l" pos="900000"/>
                <a:tab algn="l" pos="1800360"/>
                <a:tab algn="l" pos="2700360"/>
                <a:tab algn="l" pos="3600360"/>
                <a:tab algn="l" pos="4500720"/>
                <a:tab algn="l" pos="5400720"/>
                <a:tab algn="l" pos="6300720"/>
                <a:tab algn="l" pos="7201080"/>
                <a:tab algn="l" pos="8101080"/>
                <a:tab algn="l" pos="9001080"/>
                <a:tab algn="l" pos="9901080"/>
                <a:tab algn="l" pos="1080144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49280" y="9834480"/>
            <a:ext cx="2100240" cy="75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74760" y="9834480"/>
            <a:ext cx="2849400" cy="75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0120" y="9834480"/>
            <a:ext cx="2100240" cy="75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788B19-E374-4E5B-AA83-9FCB1A7DAA0C}" type="slidenum">
              <a:rPr b="0" lang="zh-CN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6.wmf"/><Relationship Id="rId5" Type="http://schemas.openxmlformats.org/officeDocument/2006/relationships/image" Target="../media/image7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wmf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3"/>
          <p:cNvGrpSpPr/>
          <p:nvPr/>
        </p:nvGrpSpPr>
        <p:grpSpPr>
          <a:xfrm>
            <a:off x="2336400" y="1079640"/>
            <a:ext cx="3975120" cy="2597040"/>
            <a:chOff x="2336400" y="1079640"/>
            <a:chExt cx="3975120" cy="2597040"/>
          </a:xfrm>
        </p:grpSpPr>
        <p:grpSp>
          <p:nvGrpSpPr>
            <p:cNvPr id="49" name="组合 11"/>
            <p:cNvGrpSpPr/>
            <p:nvPr/>
          </p:nvGrpSpPr>
          <p:grpSpPr>
            <a:xfrm>
              <a:off x="2336400" y="1079640"/>
              <a:ext cx="3975120" cy="2597040"/>
              <a:chOff x="2336400" y="1079640"/>
              <a:chExt cx="3975120" cy="2597040"/>
            </a:xfrm>
          </p:grpSpPr>
          <p:sp>
            <p:nvSpPr>
              <p:cNvPr id="50" name="文本框 1"/>
              <p:cNvSpPr/>
              <p:nvPr/>
            </p:nvSpPr>
            <p:spPr>
              <a:xfrm>
                <a:off x="2336400" y="2147040"/>
                <a:ext cx="671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TTPA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文本框 3"/>
              <p:cNvSpPr/>
              <p:nvPr/>
            </p:nvSpPr>
            <p:spPr>
              <a:xfrm>
                <a:off x="2340360" y="2466360"/>
                <a:ext cx="681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β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2" name="组合 10"/>
              <p:cNvGrpSpPr/>
              <p:nvPr/>
            </p:nvGrpSpPr>
            <p:grpSpPr>
              <a:xfrm>
                <a:off x="2377800" y="1079640"/>
                <a:ext cx="3933720" cy="2597040"/>
                <a:chOff x="2377800" y="1079640"/>
                <a:chExt cx="3933720" cy="2597040"/>
              </a:xfrm>
            </p:grpSpPr>
            <p:sp>
              <p:nvSpPr>
                <p:cNvPr id="53" name="直接连接符 20"/>
                <p:cNvSpPr/>
                <p:nvPr/>
              </p:nvSpPr>
              <p:spPr>
                <a:xfrm>
                  <a:off x="3395520" y="1355760"/>
                  <a:ext cx="2649600" cy="28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4" name="组合 9"/>
                <p:cNvGrpSpPr/>
                <p:nvPr/>
              </p:nvGrpSpPr>
              <p:grpSpPr>
                <a:xfrm>
                  <a:off x="2377800" y="1079640"/>
                  <a:ext cx="3933720" cy="2597040"/>
                  <a:chOff x="2377800" y="1079640"/>
                  <a:chExt cx="3933720" cy="2597040"/>
                </a:xfrm>
              </p:grpSpPr>
              <p:sp>
                <p:nvSpPr>
                  <p:cNvPr id="55" name="文本框 24"/>
                  <p:cNvSpPr/>
                  <p:nvPr/>
                </p:nvSpPr>
                <p:spPr>
                  <a:xfrm>
                    <a:off x="4228560" y="1079640"/>
                    <a:ext cx="10828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Cancer cells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56" name="组合 12"/>
                  <p:cNvGrpSpPr/>
                  <p:nvPr/>
                </p:nvGrpSpPr>
                <p:grpSpPr>
                  <a:xfrm>
                    <a:off x="3312720" y="1299240"/>
                    <a:ext cx="2831400" cy="753480"/>
                    <a:chOff x="3312720" y="1299240"/>
                    <a:chExt cx="2831400" cy="753480"/>
                  </a:xfrm>
                </p:grpSpPr>
                <p:sp>
                  <p:nvSpPr>
                    <p:cNvPr id="57" name="文本框 16"/>
                    <p:cNvSpPr/>
                    <p:nvPr/>
                  </p:nvSpPr>
                  <p:spPr>
                    <a:xfrm flipV="1">
                      <a:off x="5781240" y="1644480"/>
                      <a:ext cx="362880" cy="408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 vert="eaVer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2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" name="文本框 8"/>
                    <p:cNvSpPr/>
                    <p:nvPr/>
                  </p:nvSpPr>
                  <p:spPr>
                    <a:xfrm flipV="1">
                      <a:off x="3312720" y="1443600"/>
                      <a:ext cx="362880" cy="60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 vert="eaVer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" name="文本框 5"/>
                    <p:cNvSpPr/>
                    <p:nvPr/>
                  </p:nvSpPr>
                  <p:spPr>
                    <a:xfrm flipH="1" flipV="1">
                      <a:off x="4521960" y="1376280"/>
                      <a:ext cx="362880" cy="6728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 vert="eaVer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KN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" name="文本框 6"/>
                    <p:cNvSpPr/>
                    <p:nvPr/>
                  </p:nvSpPr>
                  <p:spPr>
                    <a:xfrm flipV="1">
                      <a:off x="5017680" y="1440720"/>
                      <a:ext cx="362880" cy="610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 vert="eaVer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KN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" name="文本框 7"/>
                    <p:cNvSpPr/>
                    <p:nvPr/>
                  </p:nvSpPr>
                  <p:spPr>
                    <a:xfrm flipH="1" flipV="1">
                      <a:off x="5403240" y="1299240"/>
                      <a:ext cx="362880" cy="7509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 vert="eaVer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GC8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" name="文本框 9"/>
                    <p:cNvSpPr/>
                    <p:nvPr/>
                  </p:nvSpPr>
                  <p:spPr>
                    <a:xfrm flipV="1">
                      <a:off x="3716640" y="1362960"/>
                      <a:ext cx="362880" cy="6886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 vert="eaVer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GC8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" name="文本框 8"/>
                    <p:cNvSpPr/>
                    <p:nvPr/>
                  </p:nvSpPr>
                  <p:spPr>
                    <a:xfrm flipV="1">
                      <a:off x="4104000" y="1449000"/>
                      <a:ext cx="362880" cy="6033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 vert="eaVer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CG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64" name="组合 13"/>
                  <p:cNvGrpSpPr/>
                  <p:nvPr/>
                </p:nvGrpSpPr>
                <p:grpSpPr>
                  <a:xfrm>
                    <a:off x="2980440" y="2059200"/>
                    <a:ext cx="3331080" cy="731880"/>
                    <a:chOff x="2980440" y="2059200"/>
                    <a:chExt cx="3331080" cy="731880"/>
                  </a:xfrm>
                </p:grpSpPr>
                <p:graphicFrame>
                  <p:nvGraphicFramePr>
                    <p:cNvPr id="65" name="对象 1"/>
                    <p:cNvGraphicFramePr/>
                    <p:nvPr/>
                  </p:nvGraphicFramePr>
                  <p:xfrm>
                    <a:off x="2980440" y="2059200"/>
                    <a:ext cx="3241440" cy="360000"/>
                  </p:xfrm>
                  <a:graphic>
                    <a:graphicData uri="http://schemas.openxmlformats.org/presentationml/2006/ole">
                      <p:oleObj r:id="rId1" spid="">
                        <p:embed/>
                        <p:pic>
                          <p:nvPicPr>
                            <p:cNvPr id="66" name="对象 1" descr=""/>
                            <p:cNvPicPr/>
                            <p:nvPr/>
                          </p:nvPicPr>
                          <p:blipFill>
                            <a:blip r:embed="rId2"/>
                            <a:stretch/>
                          </p:blipFill>
                          <p:spPr>
                            <a:xfrm>
                              <a:off x="2980440" y="2059200"/>
                              <a:ext cx="3241440" cy="360000"/>
                            </a:xfrm>
                            <a:prstGeom prst="rect">
                              <a:avLst/>
                            </a:prstGeom>
                            <a:ln w="0">
                              <a:noFill/>
                            </a:ln>
                          </p:spPr>
                        </p:pic>
                      </p:oleObj>
                    </a:graphicData>
                  </a:graphic>
                </p:graphicFrame>
                <p:graphicFrame>
                  <p:nvGraphicFramePr>
                    <p:cNvPr id="67" name="对象 10"/>
                    <p:cNvGraphicFramePr/>
                    <p:nvPr/>
                  </p:nvGraphicFramePr>
                  <p:xfrm>
                    <a:off x="2981520" y="2431080"/>
                    <a:ext cx="3330000" cy="360000"/>
                  </p:xfrm>
                  <a:graphic>
                    <a:graphicData uri="http://schemas.openxmlformats.org/presentationml/2006/ole">
                      <p:oleObj r:id="rId3" spid="">
                        <p:embed/>
                        <p:pic>
                          <p:nvPicPr>
                            <p:cNvPr id="68" name="对象 10" descr=""/>
                            <p:cNvPicPr/>
                            <p:nvPr/>
                          </p:nvPicPr>
                          <p:blipFill>
                            <a:blip r:embed="rId4"/>
                            <a:stretch/>
                          </p:blipFill>
                          <p:spPr>
                            <a:xfrm>
                              <a:off x="2981520" y="2431080"/>
                              <a:ext cx="3330000" cy="360000"/>
                            </a:xfrm>
                            <a:prstGeom prst="rect">
                              <a:avLst/>
                            </a:prstGeom>
                            <a:ln w="0">
                              <a:noFill/>
                            </a:ln>
                          </p:spPr>
                        </p:pic>
                      </p:oleObj>
                    </a:graphicData>
                  </a:graphic>
                </p:graphicFrame>
              </p:grpSp>
              <p:grpSp>
                <p:nvGrpSpPr>
                  <p:cNvPr id="69" name="组合 8"/>
                  <p:cNvGrpSpPr/>
                  <p:nvPr/>
                </p:nvGrpSpPr>
                <p:grpSpPr>
                  <a:xfrm>
                    <a:off x="2377800" y="2899440"/>
                    <a:ext cx="3803400" cy="777240"/>
                    <a:chOff x="2377800" y="2899440"/>
                    <a:chExt cx="3803400" cy="777240"/>
                  </a:xfrm>
                </p:grpSpPr>
                <p:sp>
                  <p:nvSpPr>
                    <p:cNvPr id="70" name="文本框 1"/>
                    <p:cNvSpPr/>
                    <p:nvPr/>
                  </p:nvSpPr>
                  <p:spPr>
                    <a:xfrm>
                      <a:off x="2377800" y="2899440"/>
                      <a:ext cx="67140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P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1" name="文本框 3"/>
                    <p:cNvSpPr/>
                    <p:nvPr/>
                  </p:nvSpPr>
                  <p:spPr>
                    <a:xfrm>
                      <a:off x="2382840" y="3344040"/>
                      <a:ext cx="68184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ac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aphicFrame>
                  <p:nvGraphicFramePr>
                    <p:cNvPr id="72" name="对象 5"/>
                    <p:cNvGraphicFramePr/>
                    <p:nvPr/>
                  </p:nvGraphicFramePr>
                  <p:xfrm>
                    <a:off x="3228840" y="3317400"/>
                    <a:ext cx="2952360" cy="359280"/>
                  </p:xfrm>
                  <a:graphic>
                    <a:graphicData uri="http://schemas.openxmlformats.org/presentationml/2006/ole">
                      <p:oleObj r:id="rId5" spid="">
                        <p:embed/>
                        <p:pic>
                          <p:nvPicPr>
                            <p:cNvPr id="73" name="对象 5" descr=""/>
                            <p:cNvPicPr/>
                            <p:nvPr/>
                          </p:nvPicPr>
                          <p:blipFill>
                            <a:blip r:embed="rId6"/>
                            <a:stretch/>
                          </p:blipFill>
                          <p:spPr>
                            <a:xfrm>
                              <a:off x="3228840" y="3317400"/>
                              <a:ext cx="2952360" cy="359280"/>
                            </a:xfrm>
                            <a:prstGeom prst="rect">
                              <a:avLst/>
                            </a:prstGeom>
                            <a:ln w="9360">
                              <a:solidFill>
                                <a:srgbClr val="000000"/>
                              </a:solidFill>
                              <a:round/>
                            </a:ln>
                          </p:spPr>
                        </p:pic>
                      </p:oleObj>
                    </a:graphicData>
                  </a:graphic>
                </p:graphicFrame>
              </p:grpSp>
            </p:grpSp>
          </p:grpSp>
        </p:grpSp>
        <p:graphicFrame>
          <p:nvGraphicFramePr>
            <p:cNvPr id="74" name="对象 1"/>
            <p:cNvGraphicFramePr/>
            <p:nvPr/>
          </p:nvGraphicFramePr>
          <p:xfrm>
            <a:off x="3228480" y="2856240"/>
            <a:ext cx="2952720" cy="36144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75" name="对象 1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3228480" y="2856240"/>
                      <a:ext cx="2952720" cy="361440"/>
                    </a:xfrm>
                    <a:prstGeom prst="rect">
                      <a:avLst/>
                    </a:prstGeom>
                    <a:ln w="6480">
                      <a:solidFill>
                        <a:srgbClr val="000000"/>
                      </a:solidFill>
                      <a:round/>
                    </a:ln>
                  </p:spPr>
                </p:pic>
              </p:oleObj>
            </a:graphicData>
          </a:graphic>
        </p:graphicFrame>
      </p:grpSp>
      <p:sp>
        <p:nvSpPr>
          <p:cNvPr id="76" name="文本框 8"/>
          <p:cNvSpPr/>
          <p:nvPr/>
        </p:nvSpPr>
        <p:spPr>
          <a:xfrm>
            <a:off x="270000" y="4264200"/>
            <a:ext cx="7920000" cy="75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Supplementary Figure 1. Expression of TTPAL in Gastric cancer cell line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TTPAL was overexpressed in 4 out of 6 GC cells (AGS, HCG27,MKN74 and MKN45), weak expressed in BGC823 and MGC803 cells,  as determined by RT-PCR and Western blot 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文本框 7"/>
          <p:cNvSpPr/>
          <p:nvPr/>
        </p:nvSpPr>
        <p:spPr>
          <a:xfrm>
            <a:off x="145800" y="21600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等线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组合 9"/>
          <p:cNvGrpSpPr/>
          <p:nvPr/>
        </p:nvGrpSpPr>
        <p:grpSpPr>
          <a:xfrm>
            <a:off x="2560680" y="792000"/>
            <a:ext cx="3879360" cy="7396200"/>
            <a:chOff x="2560680" y="792000"/>
            <a:chExt cx="3879360" cy="7396200"/>
          </a:xfrm>
        </p:grpSpPr>
        <p:grpSp>
          <p:nvGrpSpPr>
            <p:cNvPr id="79" name="组合 1"/>
            <p:cNvGrpSpPr/>
            <p:nvPr/>
          </p:nvGrpSpPr>
          <p:grpSpPr>
            <a:xfrm>
              <a:off x="2560680" y="792000"/>
              <a:ext cx="3879360" cy="1967040"/>
              <a:chOff x="2560680" y="792000"/>
              <a:chExt cx="3879360" cy="1967040"/>
            </a:xfrm>
          </p:grpSpPr>
          <p:graphicFrame>
            <p:nvGraphicFramePr>
              <p:cNvPr id="80" name="对象 6"/>
              <p:cNvGraphicFramePr/>
              <p:nvPr/>
            </p:nvGraphicFramePr>
            <p:xfrm>
              <a:off x="2560680" y="792000"/>
              <a:ext cx="2102760" cy="196704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81" name="对象 6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2560680" y="792000"/>
                        <a:ext cx="2102760" cy="1967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82" name="对象 8"/>
              <p:cNvGraphicFramePr/>
              <p:nvPr/>
            </p:nvGraphicFramePr>
            <p:xfrm>
              <a:off x="4372560" y="806040"/>
              <a:ext cx="2067480" cy="193680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83" name="对象 8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4372560" y="806040"/>
                        <a:ext cx="2067480" cy="19368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pic>
          <p:nvPicPr>
            <p:cNvPr id="84" name="图片 8" descr=""/>
            <p:cNvPicPr/>
            <p:nvPr/>
          </p:nvPicPr>
          <p:blipFill>
            <a:blip r:embed="rId5"/>
            <a:stretch/>
          </p:blipFill>
          <p:spPr>
            <a:xfrm>
              <a:off x="2604600" y="2954880"/>
              <a:ext cx="3781080" cy="52333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5" name="文本框 7"/>
          <p:cNvSpPr/>
          <p:nvPr/>
        </p:nvSpPr>
        <p:spPr>
          <a:xfrm>
            <a:off x="124560" y="14292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等线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文本框 10"/>
          <p:cNvSpPr/>
          <p:nvPr/>
        </p:nvSpPr>
        <p:spPr>
          <a:xfrm>
            <a:off x="195120" y="8412120"/>
            <a:ext cx="83534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Supplementary Figure 2. </a:t>
            </a:r>
            <a:r>
              <a:rPr b="0" lang="en-US" sz="1200" spc="-1" strike="noStrike">
                <a:solidFill>
                  <a:srgbClr val="231f20"/>
                </a:solidFill>
                <a:latin typeface="Arial"/>
                <a:ea typeface="TimesNewRomanPSMT"/>
              </a:rPr>
              <a:t>TTPAL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NewRomanPSMT"/>
              </a:rPr>
              <a:t>expression </a:t>
            </a:r>
            <a:r>
              <a:rPr b="0" lang="en-US" sz="1200" spc="-1" strike="noStrike">
                <a:solidFill>
                  <a:srgbClr val="231f20"/>
                </a:solidFill>
                <a:latin typeface="Arial"/>
                <a:ea typeface="TimesNewRomanPSMT"/>
              </a:rPr>
              <a:t>positively correlated with multiple target genes of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NewRomanPSMT"/>
              </a:rPr>
              <a:t>PI3K/AKT signaling </a:t>
            </a:r>
            <a:r>
              <a:rPr b="0" lang="en-US" sz="1200" spc="-1" strike="noStrike">
                <a:solidFill>
                  <a:srgbClr val="231f20"/>
                </a:solidFill>
                <a:latin typeface="Arial"/>
                <a:ea typeface="TimesNewRomanPSMT"/>
              </a:rPr>
              <a:t>in primary GC tissues from TCGA cohort, including SRF, EIF4EBP1, RPS6KA1, PRKCZ, ILK, TIRAP, MAPK3, GRB10 and PRKCA. On the other hand, TTPAL expression was negatively correlated with PTE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文本框 7"/>
          <p:cNvSpPr/>
          <p:nvPr/>
        </p:nvSpPr>
        <p:spPr>
          <a:xfrm>
            <a:off x="124560" y="14292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等线"/>
              </a:rPr>
              <a:t>Supplementary Figur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文本框 62"/>
          <p:cNvSpPr/>
          <p:nvPr/>
        </p:nvSpPr>
        <p:spPr>
          <a:xfrm>
            <a:off x="39600" y="3122640"/>
            <a:ext cx="719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Supplementary Figure 3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mRNA level of NNMT was not changed by overexpression of TTPAL</a:t>
            </a:r>
            <a:r>
              <a:rPr b="0" lang="en-US" sz="1200" spc="-1" strike="noStrike">
                <a:solidFill>
                  <a:srgbClr val="231f20"/>
                </a:solidFill>
                <a:latin typeface="Arial"/>
                <a:ea typeface="TimesNewRomanPSMT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组合 7"/>
          <p:cNvGrpSpPr/>
          <p:nvPr/>
        </p:nvGrpSpPr>
        <p:grpSpPr>
          <a:xfrm>
            <a:off x="3298680" y="1090440"/>
            <a:ext cx="2403720" cy="1872000"/>
            <a:chOff x="3298680" y="1090440"/>
            <a:chExt cx="2403720" cy="1872000"/>
          </a:xfrm>
        </p:grpSpPr>
        <p:sp>
          <p:nvSpPr>
            <p:cNvPr id="90" name="文本框 2"/>
            <p:cNvSpPr/>
            <p:nvPr/>
          </p:nvSpPr>
          <p:spPr>
            <a:xfrm>
              <a:off x="4046400" y="1090440"/>
              <a:ext cx="73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GC8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文本框 5"/>
            <p:cNvSpPr/>
            <p:nvPr/>
          </p:nvSpPr>
          <p:spPr>
            <a:xfrm rot="16200000">
              <a:off x="3916800" y="1463760"/>
              <a:ext cx="59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文本框 6"/>
            <p:cNvSpPr/>
            <p:nvPr/>
          </p:nvSpPr>
          <p:spPr>
            <a:xfrm rot="16200000">
              <a:off x="4271040" y="1458720"/>
              <a:ext cx="60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TP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接连接符 45"/>
            <p:cNvSpPr/>
            <p:nvPr/>
          </p:nvSpPr>
          <p:spPr>
            <a:xfrm>
              <a:off x="4118760" y="1306440"/>
              <a:ext cx="539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文本框 22"/>
            <p:cNvSpPr/>
            <p:nvPr/>
          </p:nvSpPr>
          <p:spPr>
            <a:xfrm>
              <a:off x="4767480" y="1090440"/>
              <a:ext cx="809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GC80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文本框 23"/>
            <p:cNvSpPr/>
            <p:nvPr/>
          </p:nvSpPr>
          <p:spPr>
            <a:xfrm rot="16200000">
              <a:off x="4636080" y="1463760"/>
              <a:ext cx="59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文本框 24"/>
            <p:cNvSpPr/>
            <p:nvPr/>
          </p:nvSpPr>
          <p:spPr>
            <a:xfrm rot="16200000">
              <a:off x="4924800" y="145692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TP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直接连接符 49"/>
            <p:cNvSpPr/>
            <p:nvPr/>
          </p:nvSpPr>
          <p:spPr>
            <a:xfrm>
              <a:off x="4838760" y="1306440"/>
              <a:ext cx="539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文本框 7"/>
            <p:cNvSpPr/>
            <p:nvPr/>
          </p:nvSpPr>
          <p:spPr>
            <a:xfrm>
              <a:off x="3298680" y="1923840"/>
              <a:ext cx="67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TP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文本框 8"/>
            <p:cNvSpPr/>
            <p:nvPr/>
          </p:nvSpPr>
          <p:spPr>
            <a:xfrm>
              <a:off x="3411360" y="2292480"/>
              <a:ext cx="56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NM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文本框 17"/>
            <p:cNvSpPr/>
            <p:nvPr/>
          </p:nvSpPr>
          <p:spPr>
            <a:xfrm>
              <a:off x="3298680" y="2660760"/>
              <a:ext cx="67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β-ac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1" name="图片 2" descr=""/>
            <p:cNvPicPr/>
            <p:nvPr/>
          </p:nvPicPr>
          <p:blipFill>
            <a:blip r:embed="rId1"/>
            <a:stretch/>
          </p:blipFill>
          <p:spPr>
            <a:xfrm>
              <a:off x="3902760" y="1810440"/>
              <a:ext cx="1799640" cy="36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图片 4" descr=""/>
            <p:cNvPicPr/>
            <p:nvPr/>
          </p:nvPicPr>
          <p:blipFill>
            <a:blip r:embed="rId2"/>
            <a:stretch/>
          </p:blipFill>
          <p:spPr>
            <a:xfrm>
              <a:off x="3902760" y="2206440"/>
              <a:ext cx="1799640" cy="36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图片 6" descr=""/>
            <p:cNvPicPr/>
            <p:nvPr/>
          </p:nvPicPr>
          <p:blipFill>
            <a:blip r:embed="rId3"/>
            <a:stretch/>
          </p:blipFill>
          <p:spPr>
            <a:xfrm>
              <a:off x="3902760" y="2602440"/>
              <a:ext cx="1799640" cy="36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4" name="文本框 24"/>
            <p:cNvSpPr/>
            <p:nvPr/>
          </p:nvSpPr>
          <p:spPr>
            <a:xfrm rot="16200000">
              <a:off x="5235840" y="145692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2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15T02:27:29Z</dcterms:created>
  <dc:creator>刘文秀</dc:creator>
  <dc:description/>
  <dc:language>en-US</dc:language>
  <cp:lastModifiedBy>Hongyan</cp:lastModifiedBy>
  <dcterms:modified xsi:type="dcterms:W3CDTF">2021-05-02T13:27:40Z</dcterms:modified>
  <cp:revision>15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9</vt:lpwstr>
  </property>
</Properties>
</file>